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632" y="5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25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126904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862137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Bef>
                <a:spcPts val="1600"/>
              </a:spcBef>
            </a:pPr>
            <a:r>
              <a:rPr lang="en-GB" sz="1800" b="1" kern="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formance of visual, manual, and </a:t>
            </a:r>
            <a:r>
              <a:rPr lang="en-GB" sz="1800" b="1" kern="0" dirty="0">
                <a:solidFill>
                  <a:srgbClr val="2F5496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tomatic</a:t>
            </a:r>
            <a:r>
              <a:rPr lang="en-GB" sz="1800" b="1" kern="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ronary calcium scoring of cardiac </a:t>
            </a:r>
            <a:r>
              <a:rPr lang="en-GB" sz="1800" b="1" kern="0" baseline="3000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800" b="1" kern="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-ammonia PET/low dose CT</a:t>
            </a:r>
            <a:endParaRPr lang="pl-PL" sz="1800" b="1" kern="0" dirty="0">
              <a:solidFill>
                <a:srgbClr val="2F5496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495300" y="2099690"/>
            <a:ext cx="8153400" cy="1634109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>
              <a:spcAft>
                <a:spcPts val="600"/>
              </a:spcAft>
            </a:pP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gdalena M. Dobrolinska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*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Sergiy V. Lazarenko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solidFill>
                  <a:srgbClr val="222222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iso M. van der Zant</a:t>
            </a:r>
            <a:r>
              <a:rPr lang="en-GB" sz="1200" baseline="30000" dirty="0">
                <a:solidFill>
                  <a:srgbClr val="222222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solidFill>
                  <a:srgbClr val="222222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Lonneke Does</a:t>
            </a:r>
            <a:r>
              <a:rPr lang="en-GB" sz="1200" baseline="30000" dirty="0">
                <a:solidFill>
                  <a:srgbClr val="222222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solidFill>
                  <a:srgbClr val="222222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Niels van der Werf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,4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iek H.J. Prakken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rcel J.W. Greuter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5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Riemer H.J.A. Slart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6</a:t>
            </a:r>
            <a:r>
              <a:rPr lang="en-GB" sz="12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Remco J. J. Knol</a:t>
            </a:r>
            <a:r>
              <a:rPr lang="en-GB" sz="1200" baseline="300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pl-PL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*equal contribution</a:t>
            </a:r>
            <a:endParaRPr lang="pl-PL" sz="900" dirty="0"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pl-PL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dical Imaging </a:t>
            </a:r>
            <a:r>
              <a:rPr lang="en-GB" sz="900" dirty="0" err="1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Departments of Radiology, Nuclear Medicine and Molecular Imaging, University of Groningen, University Medical </a:t>
            </a:r>
            <a:r>
              <a:rPr lang="en-GB" sz="900" dirty="0" err="1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roningen,</a:t>
            </a:r>
            <a:r>
              <a:rPr lang="pl-PL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herlands</a:t>
            </a:r>
            <a:r>
              <a:rPr lang="pl-PL" sz="900" dirty="0"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2. </a:t>
            </a:r>
            <a:r>
              <a:rPr lang="en-GB" sz="900" dirty="0">
                <a:solidFill>
                  <a:srgbClr val="212121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Nuclear Medicine, Northwest Clinics, Alkmaar,</a:t>
            </a:r>
            <a:r>
              <a:rPr lang="en-GB" sz="9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Netherlands</a:t>
            </a:r>
            <a:r>
              <a:rPr lang="pl-PL" sz="9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pl-PL" sz="9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Radiology, University of Utrecht, University Medical Center Utrecht, The Netherlands</a:t>
            </a:r>
            <a:r>
              <a:rPr lang="pl-PL" sz="9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4. 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Radiology &amp; Nuclear Medicine, Erasmus University Medical </a:t>
            </a:r>
            <a:r>
              <a:rPr lang="en-GB" sz="900" dirty="0" err="1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otterdam, The Netherlands</a:t>
            </a:r>
            <a:r>
              <a:rPr lang="pl-PL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5. </a:t>
            </a:r>
            <a:r>
              <a:rPr lang="en-GB" sz="900" dirty="0">
                <a:solidFill>
                  <a:srgbClr val="000000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Robotics and Mechatronics,</a:t>
            </a:r>
            <a:r>
              <a:rPr lang="en-GB" sz="900" dirty="0">
                <a:solidFill>
                  <a:srgbClr val="1C1E24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aculty of Electrical Engineering, Mathematics &amp; Computer Science, University of Twente</a:t>
            </a:r>
            <a:r>
              <a:rPr lang="pl-PL" sz="900" dirty="0">
                <a:solidFill>
                  <a:srgbClr val="1C1E24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he</a:t>
            </a:r>
            <a:r>
              <a:rPr lang="en-GB" sz="900" dirty="0">
                <a:solidFill>
                  <a:srgbClr val="1C1E24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etherlands</a:t>
            </a:r>
            <a:r>
              <a:rPr lang="pl-PL" sz="900" dirty="0">
                <a:solidFill>
                  <a:srgbClr val="1C1E24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6. </a:t>
            </a:r>
            <a:r>
              <a:rPr lang="en-GB" sz="900" dirty="0"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Biomedical Photonic Imaging, Faculty of Science and Technology, University of Twente, The Netherlands.</a:t>
            </a:r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DDFD991-FF83-499C-AF1A-2D91A674C1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8781" y="3879706"/>
            <a:ext cx="976096" cy="153178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8963F45-4C8E-43BC-B910-96F6F98E9F2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7500" t="77610" r="10833" b="12550"/>
          <a:stretch/>
        </p:blipFill>
        <p:spPr>
          <a:xfrm>
            <a:off x="6096000" y="4093251"/>
            <a:ext cx="1066800" cy="50613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355EBFE-ADA0-4105-AD99-E478B250857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3333" t="64815" r="49167" b="20370"/>
          <a:stretch/>
        </p:blipFill>
        <p:spPr>
          <a:xfrm>
            <a:off x="5970421" y="4793422"/>
            <a:ext cx="1317957" cy="39938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dirty="0"/>
              <a:t>1-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 C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oronary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A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rtery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C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alcium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 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(CAC)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scoring adds value to the prediction of major adverse cardiac events (MACE)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 not only in asymptomatic individuals, but also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 in symptomatic patients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.</a:t>
            </a:r>
            <a:r>
              <a:rPr lang="en-US" altLang="en-US" sz="1800" dirty="0"/>
              <a:t> </a:t>
            </a:r>
            <a:endParaRPr lang="pl-PL" altLang="en-US" sz="1800" dirty="0"/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2-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Traditionally, CAC score is calculated from dedicated, ECG-triggered coronary calcium scoring computed tomography (CSCT) scans following the standard manual Agatston scoring method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.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3-</a:t>
            </a:r>
            <a:r>
              <a:rPr lang="pl-PL" altLang="en-US" sz="1800" dirty="0"/>
              <a:t> Nevrtheless, i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n everyday clinical practice, myocardial perfusion imaging (MPI) positron emission tomography (PET) is preceded by non-ECG triggered low dose CT (LDCT) scans instead of CSCT scans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.</a:t>
            </a:r>
          </a:p>
          <a:p>
            <a:pPr marL="0" indent="0">
              <a:buNone/>
            </a:pPr>
            <a:endParaRPr lang="en-US" altLang="en-US" sz="1800" dirty="0"/>
          </a:p>
          <a:p>
            <a:pPr marL="0" indent="0">
              <a:buNone/>
            </a:pPr>
            <a:r>
              <a:rPr lang="en-US" altLang="en-US" sz="1800" dirty="0"/>
              <a:t>4-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As underlined </a:t>
            </a:r>
            <a:r>
              <a:rPr lang="pl-PL" sz="1800" dirty="0">
                <a:ea typeface="Times New Roman" panose="02020603050405020304" pitchFamily="18" charset="0"/>
              </a:rPr>
              <a:t>in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 Society of Cardiovascular Computed Tomography and Society of Thoracic Radiology (SCCT/STR) guidelines, calcium scores derived from LDCT scans should be reported, although there is still insufficient evidence on which method to use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.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pl-PL" altLang="en-US" sz="2000" dirty="0"/>
              <a:t>R</a:t>
            </a:r>
            <a:r>
              <a:rPr lang="en-US" altLang="en-US" sz="2000" dirty="0" err="1"/>
              <a:t>etrospective</a:t>
            </a:r>
            <a:r>
              <a:rPr lang="pl-PL" altLang="en-US" sz="2000" dirty="0"/>
              <a:t> study</a:t>
            </a:r>
            <a:r>
              <a:rPr lang="en-US" altLang="en-US" sz="2000" dirty="0"/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we included consecutive patients who underwent a </a:t>
            </a:r>
            <a:r>
              <a:rPr lang="en-GB" sz="1800" baseline="30000" dirty="0">
                <a:effectLst/>
                <a:ea typeface="Times New Roman" panose="02020603050405020304" pitchFamily="18" charset="0"/>
              </a:rPr>
              <a:t>13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N-ammonia-PET/LDCT 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scan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and a dedicated CSCT scan 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within 6 months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</a:t>
            </a:r>
            <a:r>
              <a:rPr lang="pl-PL" altLang="en-US" sz="2400" dirty="0"/>
              <a:t> 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to compare automatic, manual, and visual coronary calcium scoring performance from LDCT scans acquired during cardiac </a:t>
            </a:r>
            <a:r>
              <a:rPr lang="en-GB" sz="1800" baseline="30000" dirty="0">
                <a:effectLst/>
                <a:ea typeface="Times New Roman" panose="02020603050405020304" pitchFamily="18" charset="0"/>
              </a:rPr>
              <a:t>13</a:t>
            </a:r>
            <a:r>
              <a:rPr lang="en-GB" sz="1800" dirty="0">
                <a:effectLst/>
                <a:ea typeface="Times New Roman" panose="02020603050405020304" pitchFamily="18" charset="0"/>
              </a:rPr>
              <a:t>N-ammonia PET/CT to manual scoring from dedicated CSCT scans as the gold standard</a:t>
            </a:r>
            <a:r>
              <a:rPr lang="pl-PL" sz="1800" dirty="0">
                <a:effectLst/>
                <a:ea typeface="Times New Roman" panose="02020603050405020304" pitchFamily="18" charset="0"/>
              </a:rPr>
              <a:t>.</a:t>
            </a: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F0086A0-7DFF-4741-913D-ECDCD3CF0F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7570" y="2138149"/>
            <a:ext cx="8011735" cy="3080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CEB11D9-AE30-44E3-B80D-DECFB6AFAE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6800" y="2438400"/>
            <a:ext cx="7451045" cy="2109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1- </a:t>
            </a:r>
            <a:r>
              <a:rPr lang="pl-PL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Visual</a:t>
            </a:r>
            <a:r>
              <a:rPr lang="en-GB" sz="2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alcium scoring from LDCT scans outperformed manual and automatic analysis and showed the highest agreement with the reference CSCT.</a:t>
            </a:r>
            <a:endParaRPr lang="en-US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indent="0">
              <a:buNone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2- </a:t>
            </a:r>
            <a:r>
              <a:rPr lang="en-GB" sz="2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Within all three methods, automatic scoring gained the lowest sensitivity and NPV in calcium detectability. </a:t>
            </a:r>
            <a:endParaRPr lang="pl-PL" sz="24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indent="0">
              <a:buNone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3-</a:t>
            </a:r>
            <a:r>
              <a:rPr lang="en-GB" sz="2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Nevertheless, each of abovementioned methods correctly defined patients with CAC. </a:t>
            </a:r>
            <a:endParaRPr lang="en-US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indent="0">
              <a:buNone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4- </a:t>
            </a:r>
            <a:r>
              <a:rPr lang="en-GB" sz="2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se results provide further support for the statement that CAC can be reported from LDCT scans, with visual scoring to be the most reliable method.</a:t>
            </a:r>
            <a:endParaRPr lang="en-US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indent="0">
              <a:buNone/>
            </a:pPr>
            <a:endParaRPr lang="en-US" altLang="en-US" sz="36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5</TotalTime>
  <Words>636</Words>
  <Application>Microsoft Office PowerPoint</Application>
  <PresentationFormat>On-screen Show (4:3)</PresentationFormat>
  <Paragraphs>4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Calibri Light</vt:lpstr>
      <vt:lpstr>SsykbnAdvPTimes</vt:lpstr>
      <vt:lpstr>Times New Roman</vt:lpstr>
      <vt:lpstr>2_Office Theme</vt:lpstr>
      <vt:lpstr>Custom Design</vt:lpstr>
      <vt:lpstr>1_Custom Design</vt:lpstr>
      <vt:lpstr>Performance of visual, manual, and automatic coronary calcium scoring of cardiac 13N-ammonia PET/low dose CT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gdalena M Dobrolinska</cp:lastModifiedBy>
  <cp:revision>100</cp:revision>
  <dcterms:created xsi:type="dcterms:W3CDTF">2011-04-18T21:44:13Z</dcterms:created>
  <dcterms:modified xsi:type="dcterms:W3CDTF">2022-04-25T19:31:08Z</dcterms:modified>
</cp:coreProperties>
</file>